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134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196" autoAdjust="0"/>
    <p:restoredTop sz="94660"/>
  </p:normalViewPr>
  <p:slideViewPr>
    <p:cSldViewPr snapToGrid="0">
      <p:cViewPr varScale="1">
        <p:scale>
          <a:sx n="76" d="100"/>
          <a:sy n="76" d="100"/>
        </p:scale>
        <p:origin x="31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huster Gadi" userId="8014ead3-d102-41a2-8e53-d5bceadeebe2" providerId="ADAL" clId="{E7470423-E9D2-42EB-94C4-F83D031DF650}"/>
    <pc:docChg chg="custSel modSld">
      <pc:chgData name="Schuster Gadi" userId="8014ead3-d102-41a2-8e53-d5bceadeebe2" providerId="ADAL" clId="{E7470423-E9D2-42EB-94C4-F83D031DF650}" dt="2024-05-29T08:41:43.930" v="4" actId="1076"/>
      <pc:docMkLst>
        <pc:docMk/>
      </pc:docMkLst>
      <pc:sldChg chg="modSp mod">
        <pc:chgData name="Schuster Gadi" userId="8014ead3-d102-41a2-8e53-d5bceadeebe2" providerId="ADAL" clId="{E7470423-E9D2-42EB-94C4-F83D031DF650}" dt="2024-05-29T08:41:43.930" v="4" actId="1076"/>
        <pc:sldMkLst>
          <pc:docMk/>
          <pc:sldMk cId="2034325348" sldId="1341"/>
        </pc:sldMkLst>
        <pc:spChg chg="mod">
          <ac:chgData name="Schuster Gadi" userId="8014ead3-d102-41a2-8e53-d5bceadeebe2" providerId="ADAL" clId="{E7470423-E9D2-42EB-94C4-F83D031DF650}" dt="2024-05-29T08:41:43.930" v="4" actId="1076"/>
          <ac:spMkLst>
            <pc:docMk/>
            <pc:sldMk cId="2034325348" sldId="1341"/>
            <ac:spMk id="18" creationId="{351D47F2-9952-490B-8F22-8176E75E4E18}"/>
          </ac:spMkLst>
        </pc:spChg>
        <pc:spChg chg="mod">
          <ac:chgData name="Schuster Gadi" userId="8014ead3-d102-41a2-8e53-d5bceadeebe2" providerId="ADAL" clId="{E7470423-E9D2-42EB-94C4-F83D031DF650}" dt="2024-05-28T06:49:29.122" v="1" actId="313"/>
          <ac:spMkLst>
            <pc:docMk/>
            <pc:sldMk cId="2034325348" sldId="1341"/>
            <ac:spMk id="55" creationId="{18D0CA16-79D7-50D2-ACA1-12655DCE9869}"/>
          </ac:spMkLst>
        </pc:spChg>
        <pc:spChg chg="mod">
          <ac:chgData name="Schuster Gadi" userId="8014ead3-d102-41a2-8e53-d5bceadeebe2" providerId="ADAL" clId="{E7470423-E9D2-42EB-94C4-F83D031DF650}" dt="2024-05-28T06:49:33.174" v="3" actId="313"/>
          <ac:spMkLst>
            <pc:docMk/>
            <pc:sldMk cId="2034325348" sldId="1341"/>
            <ac:spMk id="61" creationId="{96332946-C41D-02AC-6D37-BE3997BC9C4A}"/>
          </ac:spMkLst>
        </pc:spChg>
      </pc:sldChg>
    </pc:docChg>
  </pc:docChgLst>
  <pc:docChgLst>
    <pc:chgData name="Guy Levin" userId="796a6ee1-938f-4754-82f4-44af232fdd3d" providerId="ADAL" clId="{71A9A29E-8629-4A1B-A2EC-F9D9E41292AC}"/>
    <pc:docChg chg="undo custSel modSld">
      <pc:chgData name="Guy Levin" userId="796a6ee1-938f-4754-82f4-44af232fdd3d" providerId="ADAL" clId="{71A9A29E-8629-4A1B-A2EC-F9D9E41292AC}" dt="2024-08-27T19:13:45.463" v="16" actId="20577"/>
      <pc:docMkLst>
        <pc:docMk/>
      </pc:docMkLst>
      <pc:sldChg chg="addSp delSp modSp">
        <pc:chgData name="Guy Levin" userId="796a6ee1-938f-4754-82f4-44af232fdd3d" providerId="ADAL" clId="{71A9A29E-8629-4A1B-A2EC-F9D9E41292AC}" dt="2024-08-26T09:09:15.358" v="14" actId="1076"/>
        <pc:sldMkLst>
          <pc:docMk/>
          <pc:sldMk cId="4102523903" sldId="290"/>
        </pc:sldMkLst>
        <pc:spChg chg="del">
          <ac:chgData name="Guy Levin" userId="796a6ee1-938f-4754-82f4-44af232fdd3d" providerId="ADAL" clId="{71A9A29E-8629-4A1B-A2EC-F9D9E41292AC}" dt="2024-08-26T09:08:59.611" v="12" actId="478"/>
          <ac:spMkLst>
            <pc:docMk/>
            <pc:sldMk cId="4102523903" sldId="290"/>
            <ac:spMk id="21" creationId="{058936D1-6581-426F-8746-9048BC216317}"/>
          </ac:spMkLst>
        </pc:spChg>
        <pc:spChg chg="add mod">
          <ac:chgData name="Guy Levin" userId="796a6ee1-938f-4754-82f4-44af232fdd3d" providerId="ADAL" clId="{71A9A29E-8629-4A1B-A2EC-F9D9E41292AC}" dt="2024-08-26T09:09:15.358" v="14" actId="1076"/>
          <ac:spMkLst>
            <pc:docMk/>
            <pc:sldMk cId="4102523903" sldId="290"/>
            <ac:spMk id="28" creationId="{058936D1-6581-426F-8746-9048BC216317}"/>
          </ac:spMkLst>
        </pc:spChg>
      </pc:sldChg>
      <pc:sldChg chg="addSp delSp modSp">
        <pc:chgData name="Guy Levin" userId="796a6ee1-938f-4754-82f4-44af232fdd3d" providerId="ADAL" clId="{71A9A29E-8629-4A1B-A2EC-F9D9E41292AC}" dt="2024-08-26T09:08:43.047" v="8" actId="1076"/>
        <pc:sldMkLst>
          <pc:docMk/>
          <pc:sldMk cId="1432036717" sldId="299"/>
        </pc:sldMkLst>
        <pc:spChg chg="del">
          <ac:chgData name="Guy Levin" userId="796a6ee1-938f-4754-82f4-44af232fdd3d" providerId="ADAL" clId="{71A9A29E-8629-4A1B-A2EC-F9D9E41292AC}" dt="2024-08-26T09:08:27.524" v="4" actId="478"/>
          <ac:spMkLst>
            <pc:docMk/>
            <pc:sldMk cId="1432036717" sldId="299"/>
            <ac:spMk id="3" creationId="{FAEEBF45-B1CE-41D6-8ED1-AE1699FC69DD}"/>
          </ac:spMkLst>
        </pc:spChg>
        <pc:spChg chg="add mod">
          <ac:chgData name="Guy Levin" userId="796a6ee1-938f-4754-82f4-44af232fdd3d" providerId="ADAL" clId="{71A9A29E-8629-4A1B-A2EC-F9D9E41292AC}" dt="2024-08-26T09:08:43.047" v="8" actId="1076"/>
          <ac:spMkLst>
            <pc:docMk/>
            <pc:sldMk cId="1432036717" sldId="299"/>
            <ac:spMk id="26" creationId="{C11AA62B-374B-4F49-ADFB-BCD75BCA9C29}"/>
          </ac:spMkLst>
        </pc:spChg>
        <pc:picChg chg="mod">
          <ac:chgData name="Guy Levin" userId="796a6ee1-938f-4754-82f4-44af232fdd3d" providerId="ADAL" clId="{71A9A29E-8629-4A1B-A2EC-F9D9E41292AC}" dt="2024-08-26T09:08:39.428" v="7" actId="1076"/>
          <ac:picMkLst>
            <pc:docMk/>
            <pc:sldMk cId="1432036717" sldId="299"/>
            <ac:picMk id="4" creationId="{FFC30E95-BD35-4623-996C-6B14A747A8C0}"/>
          </ac:picMkLst>
        </pc:picChg>
      </pc:sldChg>
      <pc:sldChg chg="addSp delSp modSp">
        <pc:chgData name="Guy Levin" userId="796a6ee1-938f-4754-82f4-44af232fdd3d" providerId="ADAL" clId="{71A9A29E-8629-4A1B-A2EC-F9D9E41292AC}" dt="2024-08-26T09:08:56.534" v="11" actId="1076"/>
        <pc:sldMkLst>
          <pc:docMk/>
          <pc:sldMk cId="2828842376" sldId="305"/>
        </pc:sldMkLst>
        <pc:spChg chg="del">
          <ac:chgData name="Guy Levin" userId="796a6ee1-938f-4754-82f4-44af232fdd3d" providerId="ADAL" clId="{71A9A29E-8629-4A1B-A2EC-F9D9E41292AC}" dt="2024-08-26T09:08:49.131" v="9" actId="478"/>
          <ac:spMkLst>
            <pc:docMk/>
            <pc:sldMk cId="2828842376" sldId="305"/>
            <ac:spMk id="42" creationId="{5D37DAEB-9531-4C3F-AB3B-0D625453EAAA}"/>
          </ac:spMkLst>
        </pc:spChg>
        <pc:spChg chg="add mod">
          <ac:chgData name="Guy Levin" userId="796a6ee1-938f-4754-82f4-44af232fdd3d" providerId="ADAL" clId="{71A9A29E-8629-4A1B-A2EC-F9D9E41292AC}" dt="2024-08-26T09:08:56.534" v="11" actId="1076"/>
          <ac:spMkLst>
            <pc:docMk/>
            <pc:sldMk cId="2828842376" sldId="305"/>
            <ac:spMk id="46" creationId="{5D37DAEB-9531-4C3F-AB3B-0D625453EAAA}"/>
          </ac:spMkLst>
        </pc:spChg>
      </pc:sldChg>
      <pc:sldChg chg="addSp delSp modSp">
        <pc:chgData name="Guy Levin" userId="796a6ee1-938f-4754-82f4-44af232fdd3d" providerId="ADAL" clId="{71A9A29E-8629-4A1B-A2EC-F9D9E41292AC}" dt="2024-08-27T19:13:45.463" v="16" actId="20577"/>
        <pc:sldMkLst>
          <pc:docMk/>
          <pc:sldMk cId="2034325348" sldId="1341"/>
        </pc:sldMkLst>
        <pc:spChg chg="del">
          <ac:chgData name="Guy Levin" userId="796a6ee1-938f-4754-82f4-44af232fdd3d" providerId="ADAL" clId="{71A9A29E-8629-4A1B-A2EC-F9D9E41292AC}" dt="2024-08-26T09:08:20.284" v="2" actId="478"/>
          <ac:spMkLst>
            <pc:docMk/>
            <pc:sldMk cId="2034325348" sldId="1341"/>
            <ac:spMk id="18" creationId="{351D47F2-9952-490B-8F22-8176E75E4E18}"/>
          </ac:spMkLst>
        </pc:spChg>
        <pc:spChg chg="add mod">
          <ac:chgData name="Guy Levin" userId="796a6ee1-938f-4754-82f4-44af232fdd3d" providerId="ADAL" clId="{71A9A29E-8629-4A1B-A2EC-F9D9E41292AC}" dt="2024-08-26T09:08:23.286" v="3" actId="1076"/>
          <ac:spMkLst>
            <pc:docMk/>
            <pc:sldMk cId="2034325348" sldId="1341"/>
            <ac:spMk id="31" creationId="{351D47F2-9952-490B-8F22-8176E75E4E18}"/>
          </ac:spMkLst>
        </pc:spChg>
        <pc:spChg chg="mod">
          <ac:chgData name="Guy Levin" userId="796a6ee1-938f-4754-82f4-44af232fdd3d" providerId="ADAL" clId="{71A9A29E-8629-4A1B-A2EC-F9D9E41292AC}" dt="2024-08-27T19:13:45.463" v="16" actId="20577"/>
          <ac:spMkLst>
            <pc:docMk/>
            <pc:sldMk cId="2034325348" sldId="1341"/>
            <ac:spMk id="32" creationId="{4E08334C-5551-4F10-B8D2-414AF554C9CF}"/>
          </ac:spMkLst>
        </pc:spChg>
        <pc:spChg chg="mod">
          <ac:chgData name="Guy Levin" userId="796a6ee1-938f-4754-82f4-44af232fdd3d" providerId="ADAL" clId="{71A9A29E-8629-4A1B-A2EC-F9D9E41292AC}" dt="2024-08-27T19:13:42.712" v="15" actId="20577"/>
          <ac:spMkLst>
            <pc:docMk/>
            <pc:sldMk cId="2034325348" sldId="1341"/>
            <ac:spMk id="39" creationId="{442F91BD-7E58-4516-A0E5-B1741BB1CD70}"/>
          </ac:spMkLst>
        </pc:spChg>
      </pc:sldChg>
    </pc:docChg>
  </pc:docChgLst>
  <pc:docChgLst>
    <pc:chgData name="Guy Levin" userId="796a6ee1-938f-4754-82f4-44af232fdd3d" providerId="ADAL" clId="{65675048-CCC5-4663-A5ED-1EE0BAA0D74C}"/>
    <pc:docChg chg="undo custSel modSld">
      <pc:chgData name="Guy Levin" userId="796a6ee1-938f-4754-82f4-44af232fdd3d" providerId="ADAL" clId="{65675048-CCC5-4663-A5ED-1EE0BAA0D74C}" dt="2024-06-10T12:25:06.540" v="24" actId="478"/>
      <pc:docMkLst>
        <pc:docMk/>
      </pc:docMkLst>
      <pc:sldChg chg="delSp modSp">
        <pc:chgData name="Guy Levin" userId="796a6ee1-938f-4754-82f4-44af232fdd3d" providerId="ADAL" clId="{65675048-CCC5-4663-A5ED-1EE0BAA0D74C}" dt="2024-06-10T12:25:06.540" v="24" actId="478"/>
        <pc:sldMkLst>
          <pc:docMk/>
          <pc:sldMk cId="1432036717" sldId="299"/>
        </pc:sldMkLst>
        <pc:spChg chg="mod">
          <ac:chgData name="Guy Levin" userId="796a6ee1-938f-4754-82f4-44af232fdd3d" providerId="ADAL" clId="{65675048-CCC5-4663-A5ED-1EE0BAA0D74C}" dt="2024-06-10T12:24:12.117" v="23" actId="20577"/>
          <ac:spMkLst>
            <pc:docMk/>
            <pc:sldMk cId="1432036717" sldId="299"/>
            <ac:spMk id="3" creationId="{FAEEBF45-B1CE-41D6-8ED1-AE1699FC69DD}"/>
          </ac:spMkLst>
        </pc:spChg>
        <pc:spChg chg="del">
          <ac:chgData name="Guy Levin" userId="796a6ee1-938f-4754-82f4-44af232fdd3d" providerId="ADAL" clId="{65675048-CCC5-4663-A5ED-1EE0BAA0D74C}" dt="2024-06-10T12:25:06.540" v="24" actId="478"/>
          <ac:spMkLst>
            <pc:docMk/>
            <pc:sldMk cId="1432036717" sldId="299"/>
            <ac:spMk id="26" creationId="{2F0EF0D1-ABFB-119A-65D4-C9554E040AEE}"/>
          </ac:spMkLst>
        </pc:spChg>
      </pc:sldChg>
      <pc:sldChg chg="addSp delSp modSp">
        <pc:chgData name="Guy Levin" userId="796a6ee1-938f-4754-82f4-44af232fdd3d" providerId="ADAL" clId="{65675048-CCC5-4663-A5ED-1EE0BAA0D74C}" dt="2024-06-10T12:21:54.669" v="17" actId="1076"/>
        <pc:sldMkLst>
          <pc:docMk/>
          <pc:sldMk cId="2034325348" sldId="1341"/>
        </pc:sldMkLst>
        <pc:spChg chg="del">
          <ac:chgData name="Guy Levin" userId="796a6ee1-938f-4754-82f4-44af232fdd3d" providerId="ADAL" clId="{65675048-CCC5-4663-A5ED-1EE0BAA0D74C}" dt="2024-05-28T08:25:06.213" v="5" actId="478"/>
          <ac:spMkLst>
            <pc:docMk/>
            <pc:sldMk cId="2034325348" sldId="1341"/>
            <ac:spMk id="2" creationId="{55E46FE8-192C-4312-9422-40CB7E225B57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3" creationId="{165C13E4-BA30-EEEC-9915-48143670ED7A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6" creationId="{33CB28F7-7461-3EF5-B9B7-3105B0B2206D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7" creationId="{CC2CA53A-FD0B-4E93-A8B1-720ED9487CEF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8" creationId="{71718261-F870-405A-818B-40CA1C0E0621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9" creationId="{F53BD0DB-512E-45F4-BB54-B16EAC518175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0" creationId="{92998ABC-1CA5-4925-B230-FA541E090F4D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1" creationId="{A87B4BDE-161F-4D79-9B7F-E6C5015FE53C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2" creationId="{AF079CAE-64DD-20D7-62FC-A8309E8F4D39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13" creationId="{7DE3C3B9-D187-A150-9245-94703824B1DD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14" creationId="{45215AE7-9B66-D777-8C8C-7FBC30B43652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8" creationId="{351D47F2-9952-490B-8F22-8176E75E4E18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9" creationId="{3EAF3056-30CA-4278-A4D3-F03EBD4B6945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27" creationId="{CFBCC9AD-A44C-4320-A224-5A980C2F45AE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32" creationId="{4E08334C-5551-4F10-B8D2-414AF554C9CF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39" creationId="{442F91BD-7E58-4516-A0E5-B1741BB1CD70}"/>
          </ac:spMkLst>
        </pc:spChg>
        <pc:spChg chg="add del mod">
          <ac:chgData name="Guy Levin" userId="796a6ee1-938f-4754-82f4-44af232fdd3d" providerId="ADAL" clId="{65675048-CCC5-4663-A5ED-1EE0BAA0D74C}" dt="2024-06-10T12:21:45.788" v="16" actId="478"/>
          <ac:spMkLst>
            <pc:docMk/>
            <pc:sldMk cId="2034325348" sldId="1341"/>
            <ac:spMk id="42" creationId="{F54F0CF5-7E95-9CF3-D830-D6C8FE1DDA12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3" creationId="{C48E2339-A1DD-771A-80C7-9940FC2FABB5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4" creationId="{90CF2406-3037-9C9C-AF1E-DE7FA3E90D61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5" creationId="{D36347BB-CBDC-25D6-7DF2-50711EC7F98E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6" creationId="{08DD1927-D977-D767-A09F-140F79C784B0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7" creationId="{CF8A812E-FB7B-D64B-A87E-71041EBFC7E8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8" creationId="{DA840B66-9B47-8EA6-9183-B6D11B2648B3}"/>
          </ac:spMkLst>
        </pc:spChg>
        <pc:spChg chg="del">
          <ac:chgData name="Guy Levin" userId="796a6ee1-938f-4754-82f4-44af232fdd3d" providerId="ADAL" clId="{65675048-CCC5-4663-A5ED-1EE0BAA0D74C}" dt="2024-05-28T08:24:56.670" v="3" actId="478"/>
          <ac:spMkLst>
            <pc:docMk/>
            <pc:sldMk cId="2034325348" sldId="1341"/>
            <ac:spMk id="49" creationId="{E7741978-D8C9-2318-5BF5-1DBF5E6B8D0A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0" creationId="{61E5856D-B67D-8DE6-EBDC-E066CE75D44B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1" creationId="{AB10EBB5-A46F-7696-9F1A-887F9817DBA5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2" creationId="{56642583-FDEC-457F-5062-C68A665985C6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3" creationId="{3C8F68FA-E444-0ECD-0207-B9E3B00412A4}"/>
          </ac:spMkLst>
        </pc:spChg>
        <pc:spChg chg="del">
          <ac:chgData name="Guy Levin" userId="796a6ee1-938f-4754-82f4-44af232fdd3d" providerId="ADAL" clId="{65675048-CCC5-4663-A5ED-1EE0BAA0D74C}" dt="2024-05-28T08:24:56.670" v="3" actId="478"/>
          <ac:spMkLst>
            <pc:docMk/>
            <pc:sldMk cId="2034325348" sldId="1341"/>
            <ac:spMk id="54" creationId="{2286ECCD-B173-3DFA-4B20-67505863486A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55" creationId="{18D0CA16-79D7-50D2-ACA1-12655DCE9869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61" creationId="{96332946-C41D-02AC-6D37-BE3997BC9C4A}"/>
          </ac:spMkLst>
        </pc:spChg>
        <pc:spChg chg="del">
          <ac:chgData name="Guy Levin" userId="796a6ee1-938f-4754-82f4-44af232fdd3d" providerId="ADAL" clId="{65675048-CCC5-4663-A5ED-1EE0BAA0D74C}" dt="2024-05-28T08:25:09.671" v="6" actId="478"/>
          <ac:spMkLst>
            <pc:docMk/>
            <pc:sldMk cId="2034325348" sldId="1341"/>
            <ac:spMk id="65" creationId="{18CA557C-D93A-5EE2-A05D-7D7565907F58}"/>
          </ac:spMkLst>
        </pc:spChg>
        <pc:grpChg chg="del">
          <ac:chgData name="Guy Levin" userId="796a6ee1-938f-4754-82f4-44af232fdd3d" providerId="ADAL" clId="{65675048-CCC5-4663-A5ED-1EE0BAA0D74C}" dt="2024-05-28T08:25:02.940" v="4" actId="478"/>
          <ac:grpSpMkLst>
            <pc:docMk/>
            <pc:sldMk cId="2034325348" sldId="1341"/>
            <ac:grpSpMk id="29" creationId="{CC4D41E3-3319-4983-A208-66D0FC1AB5AB}"/>
          </ac:grpSpMkLst>
        </pc:grpChg>
        <pc:graphicFrameChg chg="mod">
          <ac:chgData name="Guy Levin" userId="796a6ee1-938f-4754-82f4-44af232fdd3d" providerId="ADAL" clId="{65675048-CCC5-4663-A5ED-1EE0BAA0D74C}" dt="2024-06-10T12:21:54.669" v="17" actId="1076"/>
          <ac:graphicFrameMkLst>
            <pc:docMk/>
            <pc:sldMk cId="2034325348" sldId="1341"/>
            <ac:graphicFrameMk id="24" creationId="{7A4B8413-4EA1-419B-B015-CE81E9A436DF}"/>
          </ac:graphicFrameMkLst>
        </pc:graphicFrameChg>
        <pc:graphicFrameChg chg="mod">
          <ac:chgData name="Guy Levin" userId="796a6ee1-938f-4754-82f4-44af232fdd3d" providerId="ADAL" clId="{65675048-CCC5-4663-A5ED-1EE0BAA0D74C}" dt="2024-06-10T12:21:54.669" v="17" actId="1076"/>
          <ac:graphicFrameMkLst>
            <pc:docMk/>
            <pc:sldMk cId="2034325348" sldId="1341"/>
            <ac:graphicFrameMk id="25" creationId="{D527C7FC-D266-464D-AC00-9E823F3D3132}"/>
          </ac:graphicFrameMkLst>
        </pc:graphicFrameChg>
        <pc:graphicFrameChg chg="del mod">
          <ac:chgData name="Guy Levin" userId="796a6ee1-938f-4754-82f4-44af232fdd3d" providerId="ADAL" clId="{65675048-CCC5-4663-A5ED-1EE0BAA0D74C}" dt="2024-05-28T08:25:02.940" v="4" actId="478"/>
          <ac:graphicFrameMkLst>
            <pc:docMk/>
            <pc:sldMk cId="2034325348" sldId="1341"/>
            <ac:graphicFrameMk id="26" creationId="{EDFB0453-9FA4-4A12-AAC9-712B52B6094D}"/>
          </ac:graphicFrameMkLst>
        </pc:graphicFrameChg>
        <pc:graphicFrameChg chg="del">
          <ac:chgData name="Guy Levin" userId="796a6ee1-938f-4754-82f4-44af232fdd3d" providerId="ADAL" clId="{65675048-CCC5-4663-A5ED-1EE0BAA0D74C}" dt="2024-05-28T08:24:54.321" v="2" actId="478"/>
          <ac:graphicFrameMkLst>
            <pc:docMk/>
            <pc:sldMk cId="2034325348" sldId="1341"/>
            <ac:graphicFrameMk id="33" creationId="{FC92DF1C-A388-4E18-A40A-24379A5F7132}"/>
          </ac:graphicFrameMkLst>
        </pc:graphicFrameChg>
        <pc:graphicFrameChg chg="add del mod">
          <ac:chgData name="Guy Levin" userId="796a6ee1-938f-4754-82f4-44af232fdd3d" providerId="ADAL" clId="{65675048-CCC5-4663-A5ED-1EE0BAA0D74C}" dt="2024-06-10T12:21:41.736" v="14" actId="478"/>
          <ac:graphicFrameMkLst>
            <pc:docMk/>
            <pc:sldMk cId="2034325348" sldId="1341"/>
            <ac:graphicFrameMk id="56" creationId="{D15D6FC2-6851-4B2E-847B-99E6A4252B51}"/>
          </ac:graphicFrameMkLst>
        </pc:graphicFrameChg>
        <pc:picChg chg="mod">
          <ac:chgData name="Guy Levin" userId="796a6ee1-938f-4754-82f4-44af232fdd3d" providerId="ADAL" clId="{65675048-CCC5-4663-A5ED-1EE0BAA0D74C}" dt="2024-06-10T12:21:54.669" v="17" actId="1076"/>
          <ac:picMkLst>
            <pc:docMk/>
            <pc:sldMk cId="2034325348" sldId="1341"/>
            <ac:picMk id="4" creationId="{35AB84AC-F5FF-40C7-A759-6AC20D7BDB50}"/>
          </ac:picMkLst>
        </pc:picChg>
        <pc:picChg chg="mod">
          <ac:chgData name="Guy Levin" userId="796a6ee1-938f-4754-82f4-44af232fdd3d" providerId="ADAL" clId="{65675048-CCC5-4663-A5ED-1EE0BAA0D74C}" dt="2024-06-10T12:21:54.669" v="17" actId="1076"/>
          <ac:picMkLst>
            <pc:docMk/>
            <pc:sldMk cId="2034325348" sldId="1341"/>
            <ac:picMk id="5" creationId="{A278E044-1B9A-473A-83C4-1E829CFFA60F}"/>
          </ac:picMkLst>
        </pc:pic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57" creationId="{928D54EA-EE16-194A-C19F-74BE30C7F4FC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59" creationId="{5EB2AD94-AF6F-C711-1083-456F64ED4610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0" creationId="{BB9922AD-D9C8-62A2-B090-E7A09F1482A3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2" creationId="{808387B6-212A-3E56-0137-87339CE337FB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3" creationId="{871009F6-5DD7-242F-8F13-7C84975816DC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4" creationId="{CB172AF9-73CE-263C-FBEC-C06E401178A2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31756284936243"/>
          <c:y val="4.1429352580927392E-2"/>
          <c:w val="0.75128820961534126"/>
          <c:h val="0.54749485685177623"/>
        </c:manualLayout>
      </c:layout>
      <c:scatterChart>
        <c:scatterStyle val="smoothMarker"/>
        <c:varyColors val="0"/>
        <c:ser>
          <c:idx val="2"/>
          <c:order val="0"/>
          <c:tx>
            <c:v>LL TP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P VS TAP (2000)'!$F$2:$F$36</c:f>
              <c:numCache>
                <c:formatCode>0.00</c:formatCode>
                <c:ptCount val="35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400</c:v>
                </c:pt>
                <c:pt idx="21">
                  <c:v>420</c:v>
                </c:pt>
                <c:pt idx="22">
                  <c:v>440</c:v>
                </c:pt>
                <c:pt idx="23">
                  <c:v>460</c:v>
                </c:pt>
                <c:pt idx="24">
                  <c:v>480</c:v>
                </c:pt>
                <c:pt idx="25">
                  <c:v>500</c:v>
                </c:pt>
                <c:pt idx="26">
                  <c:v>520</c:v>
                </c:pt>
                <c:pt idx="27">
                  <c:v>540</c:v>
                </c:pt>
                <c:pt idx="28">
                  <c:v>560</c:v>
                </c:pt>
                <c:pt idx="29">
                  <c:v>580</c:v>
                </c:pt>
                <c:pt idx="30">
                  <c:v>600</c:v>
                </c:pt>
                <c:pt idx="31">
                  <c:v>620</c:v>
                </c:pt>
                <c:pt idx="32">
                  <c:v>644</c:v>
                </c:pt>
                <c:pt idx="33">
                  <c:v>672</c:v>
                </c:pt>
                <c:pt idx="34">
                  <c:v>705</c:v>
                </c:pt>
              </c:numCache>
            </c:numRef>
          </c:xVal>
          <c:yVal>
            <c:numRef>
              <c:f>'TP VS TAP (2000)'!$I$2:$I$36</c:f>
              <c:numCache>
                <c:formatCode>General</c:formatCode>
                <c:ptCount val="35"/>
                <c:pt idx="0">
                  <c:v>0.06</c:v>
                </c:pt>
                <c:pt idx="1">
                  <c:v>0.151</c:v>
                </c:pt>
                <c:pt idx="2">
                  <c:v>0.17599999999999999</c:v>
                </c:pt>
                <c:pt idx="3">
                  <c:v>0.19900000000000001</c:v>
                </c:pt>
                <c:pt idx="4">
                  <c:v>0.22500000000000001</c:v>
                </c:pt>
                <c:pt idx="5">
                  <c:v>0.23300000000000001</c:v>
                </c:pt>
                <c:pt idx="6">
                  <c:v>0.247</c:v>
                </c:pt>
                <c:pt idx="7">
                  <c:v>0.25800000000000001</c:v>
                </c:pt>
                <c:pt idx="8">
                  <c:v>0.28499999999999998</c:v>
                </c:pt>
                <c:pt idx="9">
                  <c:v>0.28399999999999997</c:v>
                </c:pt>
                <c:pt idx="10">
                  <c:v>0.311</c:v>
                </c:pt>
                <c:pt idx="11">
                  <c:v>0.309</c:v>
                </c:pt>
                <c:pt idx="12">
                  <c:v>0.31900000000000001</c:v>
                </c:pt>
                <c:pt idx="13">
                  <c:v>0.33100000000000002</c:v>
                </c:pt>
                <c:pt idx="14">
                  <c:v>0.34100000000000003</c:v>
                </c:pt>
                <c:pt idx="15">
                  <c:v>0.35099999999999998</c:v>
                </c:pt>
                <c:pt idx="16">
                  <c:v>0.36099999999999999</c:v>
                </c:pt>
                <c:pt idx="17">
                  <c:v>0.372</c:v>
                </c:pt>
                <c:pt idx="18">
                  <c:v>0.379</c:v>
                </c:pt>
                <c:pt idx="19">
                  <c:v>0.35599999999999998</c:v>
                </c:pt>
                <c:pt idx="20">
                  <c:v>0.40300000000000002</c:v>
                </c:pt>
                <c:pt idx="21">
                  <c:v>0.41</c:v>
                </c:pt>
                <c:pt idx="22">
                  <c:v>0.42099999999999999</c:v>
                </c:pt>
                <c:pt idx="23">
                  <c:v>0.432</c:v>
                </c:pt>
                <c:pt idx="24">
                  <c:v>0.442</c:v>
                </c:pt>
                <c:pt idx="25">
                  <c:v>0.45800000000000002</c:v>
                </c:pt>
                <c:pt idx="26">
                  <c:v>0.46200000000000002</c:v>
                </c:pt>
                <c:pt idx="27">
                  <c:v>0.47299999999999998</c:v>
                </c:pt>
                <c:pt idx="28">
                  <c:v>0.48199999999999998</c:v>
                </c:pt>
                <c:pt idx="29">
                  <c:v>0.49399999999999999</c:v>
                </c:pt>
                <c:pt idx="30">
                  <c:v>0.52500000000000002</c:v>
                </c:pt>
                <c:pt idx="31">
                  <c:v>0.54100000000000004</c:v>
                </c:pt>
                <c:pt idx="32">
                  <c:v>0.504</c:v>
                </c:pt>
                <c:pt idx="33">
                  <c:v>0.47399999999999998</c:v>
                </c:pt>
                <c:pt idx="34">
                  <c:v>0.44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4F7-450B-AFB3-E57A5FFFF881}"/>
            </c:ext>
          </c:extLst>
        </c:ser>
        <c:ser>
          <c:idx val="3"/>
          <c:order val="1"/>
          <c:tx>
            <c:v>HL TP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TP VS TAP (2000)'!$F$2:$F$36</c:f>
              <c:numCache>
                <c:formatCode>0.00</c:formatCode>
                <c:ptCount val="35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400</c:v>
                </c:pt>
                <c:pt idx="21">
                  <c:v>420</c:v>
                </c:pt>
                <c:pt idx="22">
                  <c:v>440</c:v>
                </c:pt>
                <c:pt idx="23">
                  <c:v>460</c:v>
                </c:pt>
                <c:pt idx="24">
                  <c:v>480</c:v>
                </c:pt>
                <c:pt idx="25">
                  <c:v>500</c:v>
                </c:pt>
                <c:pt idx="26">
                  <c:v>520</c:v>
                </c:pt>
                <c:pt idx="27">
                  <c:v>540</c:v>
                </c:pt>
                <c:pt idx="28">
                  <c:v>560</c:v>
                </c:pt>
                <c:pt idx="29">
                  <c:v>580</c:v>
                </c:pt>
                <c:pt idx="30">
                  <c:v>600</c:v>
                </c:pt>
                <c:pt idx="31">
                  <c:v>620</c:v>
                </c:pt>
                <c:pt idx="32">
                  <c:v>644</c:v>
                </c:pt>
                <c:pt idx="33">
                  <c:v>672</c:v>
                </c:pt>
                <c:pt idx="34">
                  <c:v>705</c:v>
                </c:pt>
              </c:numCache>
            </c:numRef>
          </c:xVal>
          <c:yVal>
            <c:numRef>
              <c:f>'TP VS TAP (2000)'!$J$2:$J$36</c:f>
              <c:numCache>
                <c:formatCode>General</c:formatCode>
                <c:ptCount val="35"/>
                <c:pt idx="0">
                  <c:v>0.16400000000000001</c:v>
                </c:pt>
                <c:pt idx="1">
                  <c:v>0.28699999999999998</c:v>
                </c:pt>
                <c:pt idx="2">
                  <c:v>0.34</c:v>
                </c:pt>
                <c:pt idx="3">
                  <c:v>0.32500000000000001</c:v>
                </c:pt>
                <c:pt idx="4">
                  <c:v>0.30399999999999999</c:v>
                </c:pt>
                <c:pt idx="5">
                  <c:v>0.3</c:v>
                </c:pt>
                <c:pt idx="6">
                  <c:v>0.316</c:v>
                </c:pt>
                <c:pt idx="7">
                  <c:v>0.28599999999999998</c:v>
                </c:pt>
                <c:pt idx="8">
                  <c:v>0.28000000000000003</c:v>
                </c:pt>
                <c:pt idx="9">
                  <c:v>0.27200000000000002</c:v>
                </c:pt>
                <c:pt idx="10">
                  <c:v>0.26200000000000001</c:v>
                </c:pt>
                <c:pt idx="11">
                  <c:v>0.28399999999999997</c:v>
                </c:pt>
                <c:pt idx="12">
                  <c:v>0.252</c:v>
                </c:pt>
                <c:pt idx="13">
                  <c:v>0.25</c:v>
                </c:pt>
                <c:pt idx="14">
                  <c:v>0.245</c:v>
                </c:pt>
                <c:pt idx="15">
                  <c:v>0.23300000000000001</c:v>
                </c:pt>
                <c:pt idx="16">
                  <c:v>0.183</c:v>
                </c:pt>
                <c:pt idx="17">
                  <c:v>0.22900000000000001</c:v>
                </c:pt>
                <c:pt idx="18">
                  <c:v>0.22600000000000001</c:v>
                </c:pt>
                <c:pt idx="19">
                  <c:v>0.16900000000000001</c:v>
                </c:pt>
                <c:pt idx="20">
                  <c:v>0.219</c:v>
                </c:pt>
                <c:pt idx="21">
                  <c:v>0.214</c:v>
                </c:pt>
                <c:pt idx="22">
                  <c:v>0.219</c:v>
                </c:pt>
                <c:pt idx="23">
                  <c:v>0.20499999999999999</c:v>
                </c:pt>
                <c:pt idx="24">
                  <c:v>0.187</c:v>
                </c:pt>
                <c:pt idx="25">
                  <c:v>0.20200000000000001</c:v>
                </c:pt>
                <c:pt idx="26">
                  <c:v>0.19900000000000001</c:v>
                </c:pt>
                <c:pt idx="27">
                  <c:v>0.19900000000000001</c:v>
                </c:pt>
                <c:pt idx="28">
                  <c:v>0.19900000000000001</c:v>
                </c:pt>
                <c:pt idx="29">
                  <c:v>0.19700000000000001</c:v>
                </c:pt>
                <c:pt idx="30">
                  <c:v>0.23400000000000001</c:v>
                </c:pt>
                <c:pt idx="31">
                  <c:v>0.20899999999999999</c:v>
                </c:pt>
                <c:pt idx="32">
                  <c:v>0.10199999999999999</c:v>
                </c:pt>
                <c:pt idx="33">
                  <c:v>8.7999999999999995E-2</c:v>
                </c:pt>
                <c:pt idx="34">
                  <c:v>7.0999999999999994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4F7-450B-AFB3-E57A5FFFF8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7564768"/>
        <c:axId val="1678441808"/>
      </c:scatterChart>
      <c:valAx>
        <c:axId val="1687564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effectLst/>
                  </a:rPr>
                  <a:t>Time since light (seconds)</a:t>
                </a:r>
                <a:endParaRPr lang="en-IL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0.29851875499135555"/>
              <c:y val="0.8065467320823481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678441808"/>
        <c:crosses val="autoZero"/>
        <c:crossBetween val="midCat"/>
      </c:valAx>
      <c:valAx>
        <c:axId val="1678441808"/>
        <c:scaling>
          <c:orientation val="minMax"/>
          <c:max val="0.8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/>
                  <a:t>NPQ</a:t>
                </a:r>
              </a:p>
            </c:rich>
          </c:tx>
          <c:layout>
            <c:manualLayout>
              <c:xMode val="edge"/>
              <c:yMode val="edge"/>
              <c:x val="0"/>
              <c:y val="0.222812205941658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68756476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55465225935677"/>
          <c:y val="7.5398093300791086E-2"/>
          <c:w val="0.74410645017450572"/>
          <c:h val="0.71802084910759589"/>
        </c:manualLayout>
      </c:layout>
      <c:scatterChart>
        <c:scatterStyle val="smoothMarker"/>
        <c:varyColors val="0"/>
        <c:ser>
          <c:idx val="2"/>
          <c:order val="0"/>
          <c:tx>
            <c:v>LL TP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P VS TAP (2000)'!$F$2:$F$36</c:f>
              <c:numCache>
                <c:formatCode>0.00</c:formatCode>
                <c:ptCount val="35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400</c:v>
                </c:pt>
                <c:pt idx="21">
                  <c:v>420</c:v>
                </c:pt>
                <c:pt idx="22">
                  <c:v>440</c:v>
                </c:pt>
                <c:pt idx="23">
                  <c:v>460</c:v>
                </c:pt>
                <c:pt idx="24">
                  <c:v>480</c:v>
                </c:pt>
                <c:pt idx="25">
                  <c:v>500</c:v>
                </c:pt>
                <c:pt idx="26">
                  <c:v>520</c:v>
                </c:pt>
                <c:pt idx="27">
                  <c:v>540</c:v>
                </c:pt>
                <c:pt idx="28">
                  <c:v>560</c:v>
                </c:pt>
                <c:pt idx="29">
                  <c:v>580</c:v>
                </c:pt>
                <c:pt idx="30">
                  <c:v>600</c:v>
                </c:pt>
                <c:pt idx="31">
                  <c:v>620</c:v>
                </c:pt>
                <c:pt idx="32">
                  <c:v>644</c:v>
                </c:pt>
                <c:pt idx="33">
                  <c:v>672</c:v>
                </c:pt>
                <c:pt idx="34">
                  <c:v>705</c:v>
                </c:pt>
              </c:numCache>
            </c:numRef>
          </c:xVal>
          <c:yVal>
            <c:numRef>
              <c:f>'TP VS TAP (2000)'!$G$2:$G$36</c:f>
              <c:numCache>
                <c:formatCode>General</c:formatCode>
                <c:ptCount val="35"/>
                <c:pt idx="0">
                  <c:v>0.01</c:v>
                </c:pt>
                <c:pt idx="1">
                  <c:v>5.1999999999999998E-2</c:v>
                </c:pt>
                <c:pt idx="2">
                  <c:v>5.7000000000000002E-2</c:v>
                </c:pt>
                <c:pt idx="3">
                  <c:v>5.8000000000000003E-2</c:v>
                </c:pt>
                <c:pt idx="4">
                  <c:v>5.8000000000000003E-2</c:v>
                </c:pt>
                <c:pt idx="5">
                  <c:v>5.7000000000000002E-2</c:v>
                </c:pt>
                <c:pt idx="6">
                  <c:v>5.7000000000000002E-2</c:v>
                </c:pt>
                <c:pt idx="7">
                  <c:v>5.8999999999999997E-2</c:v>
                </c:pt>
                <c:pt idx="8">
                  <c:v>6.0999999999999999E-2</c:v>
                </c:pt>
                <c:pt idx="9">
                  <c:v>6.2E-2</c:v>
                </c:pt>
                <c:pt idx="10">
                  <c:v>6.5000000000000002E-2</c:v>
                </c:pt>
                <c:pt idx="11">
                  <c:v>6.6000000000000003E-2</c:v>
                </c:pt>
                <c:pt idx="12">
                  <c:v>6.7000000000000004E-2</c:v>
                </c:pt>
                <c:pt idx="13">
                  <c:v>6.8000000000000005E-2</c:v>
                </c:pt>
                <c:pt idx="14">
                  <c:v>6.9000000000000006E-2</c:v>
                </c:pt>
                <c:pt idx="15">
                  <c:v>7.0000000000000007E-2</c:v>
                </c:pt>
                <c:pt idx="16">
                  <c:v>7.0999999999999994E-2</c:v>
                </c:pt>
                <c:pt idx="17">
                  <c:v>7.1999999999999995E-2</c:v>
                </c:pt>
                <c:pt idx="18">
                  <c:v>7.2999999999999995E-2</c:v>
                </c:pt>
                <c:pt idx="19">
                  <c:v>7.2999999999999995E-2</c:v>
                </c:pt>
                <c:pt idx="20">
                  <c:v>7.3999999999999996E-2</c:v>
                </c:pt>
                <c:pt idx="21">
                  <c:v>7.3999999999999996E-2</c:v>
                </c:pt>
                <c:pt idx="22">
                  <c:v>7.0999999999999994E-2</c:v>
                </c:pt>
                <c:pt idx="23">
                  <c:v>7.3999999999999996E-2</c:v>
                </c:pt>
                <c:pt idx="24">
                  <c:v>7.3999999999999996E-2</c:v>
                </c:pt>
                <c:pt idx="25">
                  <c:v>6.9000000000000006E-2</c:v>
                </c:pt>
                <c:pt idx="26">
                  <c:v>7.2999999999999995E-2</c:v>
                </c:pt>
                <c:pt idx="27">
                  <c:v>7.1999999999999995E-2</c:v>
                </c:pt>
                <c:pt idx="28">
                  <c:v>7.0999999999999994E-2</c:v>
                </c:pt>
                <c:pt idx="29">
                  <c:v>7.1999999999999995E-2</c:v>
                </c:pt>
                <c:pt idx="30">
                  <c:v>0.433</c:v>
                </c:pt>
                <c:pt idx="31">
                  <c:v>0.504</c:v>
                </c:pt>
                <c:pt idx="32">
                  <c:v>0.52600000000000002</c:v>
                </c:pt>
                <c:pt idx="33">
                  <c:v>0.5</c:v>
                </c:pt>
                <c:pt idx="34">
                  <c:v>0.506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921-49A3-9B95-2B43CF3B997A}"/>
            </c:ext>
          </c:extLst>
        </c:ser>
        <c:ser>
          <c:idx val="3"/>
          <c:order val="1"/>
          <c:tx>
            <c:v>HL TP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TP VS TAP (2000)'!$F$2:$F$36</c:f>
              <c:numCache>
                <c:formatCode>0.00</c:formatCode>
                <c:ptCount val="35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  <c:pt idx="6">
                  <c:v>120</c:v>
                </c:pt>
                <c:pt idx="7">
                  <c:v>140</c:v>
                </c:pt>
                <c:pt idx="8">
                  <c:v>160</c:v>
                </c:pt>
                <c:pt idx="9">
                  <c:v>180</c:v>
                </c:pt>
                <c:pt idx="10">
                  <c:v>200</c:v>
                </c:pt>
                <c:pt idx="11">
                  <c:v>220</c:v>
                </c:pt>
                <c:pt idx="12">
                  <c:v>240</c:v>
                </c:pt>
                <c:pt idx="13">
                  <c:v>260</c:v>
                </c:pt>
                <c:pt idx="14">
                  <c:v>280</c:v>
                </c:pt>
                <c:pt idx="15">
                  <c:v>300</c:v>
                </c:pt>
                <c:pt idx="16">
                  <c:v>320</c:v>
                </c:pt>
                <c:pt idx="17">
                  <c:v>340</c:v>
                </c:pt>
                <c:pt idx="18">
                  <c:v>360</c:v>
                </c:pt>
                <c:pt idx="19">
                  <c:v>380</c:v>
                </c:pt>
                <c:pt idx="20">
                  <c:v>400</c:v>
                </c:pt>
                <c:pt idx="21">
                  <c:v>420</c:v>
                </c:pt>
                <c:pt idx="22">
                  <c:v>440</c:v>
                </c:pt>
                <c:pt idx="23">
                  <c:v>460</c:v>
                </c:pt>
                <c:pt idx="24">
                  <c:v>480</c:v>
                </c:pt>
                <c:pt idx="25">
                  <c:v>500</c:v>
                </c:pt>
                <c:pt idx="26">
                  <c:v>520</c:v>
                </c:pt>
                <c:pt idx="27">
                  <c:v>540</c:v>
                </c:pt>
                <c:pt idx="28">
                  <c:v>560</c:v>
                </c:pt>
                <c:pt idx="29">
                  <c:v>580</c:v>
                </c:pt>
                <c:pt idx="30">
                  <c:v>600</c:v>
                </c:pt>
                <c:pt idx="31">
                  <c:v>620</c:v>
                </c:pt>
                <c:pt idx="32">
                  <c:v>644</c:v>
                </c:pt>
                <c:pt idx="33">
                  <c:v>672</c:v>
                </c:pt>
                <c:pt idx="34">
                  <c:v>705</c:v>
                </c:pt>
              </c:numCache>
            </c:numRef>
          </c:xVal>
          <c:yVal>
            <c:numRef>
              <c:f>'TP VS TAP (2000)'!$H$2:$H$36</c:f>
              <c:numCache>
                <c:formatCode>General</c:formatCode>
                <c:ptCount val="35"/>
                <c:pt idx="0">
                  <c:v>0.114</c:v>
                </c:pt>
                <c:pt idx="1">
                  <c:v>0.14499999999999999</c:v>
                </c:pt>
                <c:pt idx="2">
                  <c:v>0.152</c:v>
                </c:pt>
                <c:pt idx="3">
                  <c:v>0.16800000000000001</c:v>
                </c:pt>
                <c:pt idx="4">
                  <c:v>0.17399999999999999</c:v>
                </c:pt>
                <c:pt idx="5">
                  <c:v>0.182</c:v>
                </c:pt>
                <c:pt idx="6">
                  <c:v>0.193</c:v>
                </c:pt>
                <c:pt idx="7">
                  <c:v>0.193</c:v>
                </c:pt>
                <c:pt idx="8">
                  <c:v>0.19600000000000001</c:v>
                </c:pt>
                <c:pt idx="9">
                  <c:v>0.19800000000000001</c:v>
                </c:pt>
                <c:pt idx="10">
                  <c:v>0.19800000000000001</c:v>
                </c:pt>
                <c:pt idx="11">
                  <c:v>0.20499999999999999</c:v>
                </c:pt>
                <c:pt idx="12">
                  <c:v>0.20100000000000001</c:v>
                </c:pt>
                <c:pt idx="13">
                  <c:v>0.19700000000000001</c:v>
                </c:pt>
                <c:pt idx="14">
                  <c:v>0.19500000000000001</c:v>
                </c:pt>
                <c:pt idx="15">
                  <c:v>0.193</c:v>
                </c:pt>
                <c:pt idx="16">
                  <c:v>0.182</c:v>
                </c:pt>
                <c:pt idx="17">
                  <c:v>0.18</c:v>
                </c:pt>
                <c:pt idx="18">
                  <c:v>0.17399999999999999</c:v>
                </c:pt>
                <c:pt idx="19">
                  <c:v>0.16400000000000001</c:v>
                </c:pt>
                <c:pt idx="20">
                  <c:v>0.16</c:v>
                </c:pt>
                <c:pt idx="21">
                  <c:v>0.152</c:v>
                </c:pt>
                <c:pt idx="22">
                  <c:v>0.14499999999999999</c:v>
                </c:pt>
                <c:pt idx="23">
                  <c:v>0.13900000000000001</c:v>
                </c:pt>
                <c:pt idx="24">
                  <c:v>0.13800000000000001</c:v>
                </c:pt>
                <c:pt idx="25">
                  <c:v>0.125</c:v>
                </c:pt>
                <c:pt idx="26">
                  <c:v>0.11799999999999999</c:v>
                </c:pt>
                <c:pt idx="27">
                  <c:v>0.114</c:v>
                </c:pt>
                <c:pt idx="28">
                  <c:v>0.109</c:v>
                </c:pt>
                <c:pt idx="29">
                  <c:v>0.105</c:v>
                </c:pt>
                <c:pt idx="30">
                  <c:v>0.34399999999999997</c:v>
                </c:pt>
                <c:pt idx="31">
                  <c:v>0.45200000000000001</c:v>
                </c:pt>
                <c:pt idx="32">
                  <c:v>0.52</c:v>
                </c:pt>
                <c:pt idx="33">
                  <c:v>0.52300000000000002</c:v>
                </c:pt>
                <c:pt idx="34">
                  <c:v>0.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921-49A3-9B95-2B43CF3B99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7564768"/>
        <c:axId val="1678441808"/>
      </c:scatterChart>
      <c:valAx>
        <c:axId val="1687564768"/>
        <c:scaling>
          <c:orientation val="minMax"/>
        </c:scaling>
        <c:delete val="1"/>
        <c:axPos val="b"/>
        <c:numFmt formatCode="0" sourceLinked="0"/>
        <c:majorTickMark val="none"/>
        <c:minorTickMark val="none"/>
        <c:tickLblPos val="nextTo"/>
        <c:crossAx val="1678441808"/>
        <c:crosses val="autoZero"/>
        <c:crossBetween val="midCat"/>
      </c:valAx>
      <c:valAx>
        <c:axId val="1678441808"/>
        <c:scaling>
          <c:orientation val="minMax"/>
          <c:max val="0.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/>
                  <a:t>Y(II)</a:t>
                </a:r>
              </a:p>
            </c:rich>
          </c:tx>
          <c:layout>
            <c:manualLayout>
              <c:xMode val="edge"/>
              <c:yMode val="edge"/>
              <c:x val="3.2057991429265543E-3"/>
              <c:y val="0.255976251236914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IL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168756476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09135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123372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51846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31278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620784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64341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585548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255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599523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91811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155418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628209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5AB84AC-F5FF-40C7-A759-6AC20D7BDB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059" y="1012244"/>
            <a:ext cx="2747047" cy="13326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278E044-1B9A-473A-83C4-1E829CFFA60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77" t="15013" r="-1" b="16994"/>
          <a:stretch/>
        </p:blipFill>
        <p:spPr>
          <a:xfrm>
            <a:off x="751086" y="2046765"/>
            <a:ext cx="2880295" cy="110283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C2CA53A-FD0B-4E93-A8B1-720ED9487CEF}"/>
              </a:ext>
            </a:extLst>
          </p:cNvPr>
          <p:cNvSpPr txBox="1"/>
          <p:nvPr/>
        </p:nvSpPr>
        <p:spPr>
          <a:xfrm>
            <a:off x="1638511" y="3082857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solidFill>
                  <a:schemeClr val="bg1">
                    <a:lumMod val="50000"/>
                  </a:schemeClr>
                </a:solidFill>
              </a:rPr>
              <a:t>Time (seconds)</a:t>
            </a:r>
            <a:endParaRPr lang="en-IL" sz="110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71718261-F870-405A-818B-40CA1C0E0621}"/>
              </a:ext>
            </a:extLst>
          </p:cNvPr>
          <p:cNvSpPr/>
          <p:nvPr/>
        </p:nvSpPr>
        <p:spPr>
          <a:xfrm rot="10800000">
            <a:off x="1239283" y="1821223"/>
            <a:ext cx="88017" cy="12812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F53BD0DB-512E-45F4-BB54-B16EAC518175}"/>
              </a:ext>
            </a:extLst>
          </p:cNvPr>
          <p:cNvSpPr/>
          <p:nvPr/>
        </p:nvSpPr>
        <p:spPr>
          <a:xfrm>
            <a:off x="2879771" y="1816985"/>
            <a:ext cx="88017" cy="12812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92998ABC-1CA5-4925-B230-FA541E090F4D}"/>
              </a:ext>
            </a:extLst>
          </p:cNvPr>
          <p:cNvSpPr/>
          <p:nvPr/>
        </p:nvSpPr>
        <p:spPr>
          <a:xfrm rot="10800000">
            <a:off x="1239283" y="2763903"/>
            <a:ext cx="88017" cy="12812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A87B4BDE-161F-4D79-9B7F-E6C5015FE53C}"/>
              </a:ext>
            </a:extLst>
          </p:cNvPr>
          <p:cNvSpPr/>
          <p:nvPr/>
        </p:nvSpPr>
        <p:spPr>
          <a:xfrm>
            <a:off x="2893194" y="2784357"/>
            <a:ext cx="88017" cy="12812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7A4B8413-4EA1-419B-B015-CE81E9A436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9072434"/>
              </p:ext>
            </p:extLst>
          </p:nvPr>
        </p:nvGraphicFramePr>
        <p:xfrm>
          <a:off x="3573017" y="2112049"/>
          <a:ext cx="2878727" cy="12646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D527C7FC-D266-464D-AC00-9E823F3D31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4203588"/>
              </p:ext>
            </p:extLst>
          </p:nvPr>
        </p:nvGraphicFramePr>
        <p:xfrm>
          <a:off x="3589943" y="1207519"/>
          <a:ext cx="2856698" cy="1056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3EAF3056-30CA-4278-A4D3-F03EBD4B6945}"/>
              </a:ext>
            </a:extLst>
          </p:cNvPr>
          <p:cNvSpPr txBox="1"/>
          <p:nvPr/>
        </p:nvSpPr>
        <p:spPr>
          <a:xfrm rot="16200000">
            <a:off x="135472" y="1816220"/>
            <a:ext cx="1165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solidFill>
                  <a:schemeClr val="bg1">
                    <a:lumMod val="50000"/>
                  </a:schemeClr>
                </a:solidFill>
              </a:rPr>
              <a:t>Fluorescence</a:t>
            </a:r>
            <a:endParaRPr lang="en-IL" sz="110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42F91BD-7E58-4516-A0E5-B1741BB1CD70}"/>
              </a:ext>
            </a:extLst>
          </p:cNvPr>
          <p:cNvSpPr txBox="1"/>
          <p:nvPr/>
        </p:nvSpPr>
        <p:spPr>
          <a:xfrm>
            <a:off x="650829" y="8381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endParaRPr lang="en-IL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E08334C-5551-4F10-B8D2-414AF554C9CF}"/>
              </a:ext>
            </a:extLst>
          </p:cNvPr>
          <p:cNvSpPr txBox="1"/>
          <p:nvPr/>
        </p:nvSpPr>
        <p:spPr>
          <a:xfrm>
            <a:off x="3793181" y="79664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en-IL" dirty="0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33CB28F7-7461-3EF5-B9B7-3105B0B2206D}"/>
              </a:ext>
            </a:extLst>
          </p:cNvPr>
          <p:cNvSpPr/>
          <p:nvPr/>
        </p:nvSpPr>
        <p:spPr>
          <a:xfrm>
            <a:off x="5659918" y="1364451"/>
            <a:ext cx="88017" cy="12812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AF079CAE-64DD-20D7-62FC-A8309E8F4D39}"/>
              </a:ext>
            </a:extLst>
          </p:cNvPr>
          <p:cNvSpPr/>
          <p:nvPr/>
        </p:nvSpPr>
        <p:spPr>
          <a:xfrm>
            <a:off x="5703926" y="2194841"/>
            <a:ext cx="88017" cy="128125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48E2339-A1DD-771A-80C7-9940FC2FABB5}"/>
              </a:ext>
            </a:extLst>
          </p:cNvPr>
          <p:cNvSpPr txBox="1"/>
          <p:nvPr/>
        </p:nvSpPr>
        <p:spPr>
          <a:xfrm>
            <a:off x="1284685" y="159168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LL</a:t>
            </a:r>
            <a:endParaRPr lang="en-IL" sz="1200" dirty="0">
              <a:solidFill>
                <a:srgbClr val="0070C0"/>
              </a:solidFill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0CF2406-3037-9C9C-AF1E-DE7FA3E90D61}"/>
              </a:ext>
            </a:extLst>
          </p:cNvPr>
          <p:cNvSpPr txBox="1"/>
          <p:nvPr/>
        </p:nvSpPr>
        <p:spPr>
          <a:xfrm>
            <a:off x="1300243" y="2626207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/>
                </a:solidFill>
              </a:rPr>
              <a:t>HL</a:t>
            </a:r>
            <a:endParaRPr lang="en-IL" sz="1200" dirty="0">
              <a:solidFill>
                <a:schemeClr val="accent2"/>
              </a:solidFill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36347BB-CBDC-25D6-7DF2-50711EC7F98E}"/>
              </a:ext>
            </a:extLst>
          </p:cNvPr>
          <p:cNvSpPr txBox="1"/>
          <p:nvPr/>
        </p:nvSpPr>
        <p:spPr>
          <a:xfrm>
            <a:off x="6010581" y="2645857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/>
                </a:solidFill>
              </a:rPr>
              <a:t>HL</a:t>
            </a:r>
            <a:endParaRPr lang="en-IL" sz="1200" dirty="0">
              <a:solidFill>
                <a:schemeClr val="accent2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8DD1927-D977-D767-A09F-140F79C784B0}"/>
              </a:ext>
            </a:extLst>
          </p:cNvPr>
          <p:cNvSpPr txBox="1"/>
          <p:nvPr/>
        </p:nvSpPr>
        <p:spPr>
          <a:xfrm>
            <a:off x="6009847" y="234129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LL</a:t>
            </a:r>
            <a:endParaRPr lang="en-IL" sz="1200" dirty="0">
              <a:solidFill>
                <a:srgbClr val="0070C0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F8A812E-FB7B-D64B-A87E-71041EBFC7E8}"/>
              </a:ext>
            </a:extLst>
          </p:cNvPr>
          <p:cNvSpPr txBox="1"/>
          <p:nvPr/>
        </p:nvSpPr>
        <p:spPr>
          <a:xfrm>
            <a:off x="4070397" y="1610647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/>
                </a:solidFill>
              </a:rPr>
              <a:t>HL</a:t>
            </a:r>
            <a:endParaRPr lang="en-IL" sz="1200" dirty="0">
              <a:solidFill>
                <a:schemeClr val="accent2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A840B66-9B47-8EA6-9183-B6D11B2648B3}"/>
              </a:ext>
            </a:extLst>
          </p:cNvPr>
          <p:cNvSpPr txBox="1"/>
          <p:nvPr/>
        </p:nvSpPr>
        <p:spPr>
          <a:xfrm>
            <a:off x="4086427" y="1981904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LL</a:t>
            </a:r>
            <a:endParaRPr lang="en-IL" sz="1200" dirty="0">
              <a:solidFill>
                <a:srgbClr val="0070C0"/>
              </a:solidFill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8D0CA16-79D7-50D2-ACA1-12655DCE9869}"/>
              </a:ext>
            </a:extLst>
          </p:cNvPr>
          <p:cNvSpPr txBox="1"/>
          <p:nvPr/>
        </p:nvSpPr>
        <p:spPr>
          <a:xfrm>
            <a:off x="2310378" y="879841"/>
            <a:ext cx="3658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</a:t>
            </a:r>
            <a:r>
              <a:rPr lang="en-US" sz="1200" baseline="-25000" dirty="0"/>
              <a:t>M’</a:t>
            </a:r>
            <a:endParaRPr lang="en-IL" sz="1200" baseline="-25000" dirty="0"/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928D54EA-EE16-194A-C19F-74BE30C7F4FC}"/>
              </a:ext>
            </a:extLst>
          </p:cNvPr>
          <p:cNvCxnSpPr>
            <a:cxnSpLocks/>
          </p:cNvCxnSpPr>
          <p:nvPr/>
        </p:nvCxnSpPr>
        <p:spPr>
          <a:xfrm>
            <a:off x="2537141" y="1155700"/>
            <a:ext cx="0" cy="168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5EB2AD94-AF6F-C711-1083-456F64ED4610}"/>
              </a:ext>
            </a:extLst>
          </p:cNvPr>
          <p:cNvCxnSpPr>
            <a:cxnSpLocks/>
          </p:cNvCxnSpPr>
          <p:nvPr/>
        </p:nvCxnSpPr>
        <p:spPr>
          <a:xfrm>
            <a:off x="2472406" y="1159816"/>
            <a:ext cx="0" cy="168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BB9922AD-D9C8-62A2-B090-E7A09F1482A3}"/>
              </a:ext>
            </a:extLst>
          </p:cNvPr>
          <p:cNvCxnSpPr>
            <a:cxnSpLocks/>
          </p:cNvCxnSpPr>
          <p:nvPr/>
        </p:nvCxnSpPr>
        <p:spPr>
          <a:xfrm>
            <a:off x="2420667" y="1163932"/>
            <a:ext cx="0" cy="168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96332946-C41D-02AC-6D37-BE3997BC9C4A}"/>
              </a:ext>
            </a:extLst>
          </p:cNvPr>
          <p:cNvSpPr txBox="1"/>
          <p:nvPr/>
        </p:nvSpPr>
        <p:spPr>
          <a:xfrm>
            <a:off x="2410531" y="1981904"/>
            <a:ext cx="3658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</a:t>
            </a:r>
            <a:r>
              <a:rPr lang="en-US" sz="1200" baseline="-25000" dirty="0"/>
              <a:t>M’</a:t>
            </a:r>
            <a:endParaRPr lang="en-IL" sz="1200" baseline="-25000" dirty="0"/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808387B6-212A-3E56-0137-87339CE337FB}"/>
              </a:ext>
            </a:extLst>
          </p:cNvPr>
          <p:cNvCxnSpPr>
            <a:cxnSpLocks/>
          </p:cNvCxnSpPr>
          <p:nvPr/>
        </p:nvCxnSpPr>
        <p:spPr>
          <a:xfrm>
            <a:off x="2637294" y="2257763"/>
            <a:ext cx="0" cy="168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871009F6-5DD7-242F-8F13-7C84975816DC}"/>
              </a:ext>
            </a:extLst>
          </p:cNvPr>
          <p:cNvCxnSpPr>
            <a:cxnSpLocks/>
          </p:cNvCxnSpPr>
          <p:nvPr/>
        </p:nvCxnSpPr>
        <p:spPr>
          <a:xfrm>
            <a:off x="2572559" y="2261879"/>
            <a:ext cx="0" cy="168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CB172AF9-73CE-263C-FBEC-C06E401178A2}"/>
              </a:ext>
            </a:extLst>
          </p:cNvPr>
          <p:cNvCxnSpPr>
            <a:cxnSpLocks/>
          </p:cNvCxnSpPr>
          <p:nvPr/>
        </p:nvCxnSpPr>
        <p:spPr>
          <a:xfrm>
            <a:off x="2520820" y="2265995"/>
            <a:ext cx="0" cy="1688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17">
            <a:extLst>
              <a:ext uri="{FF2B5EF4-FFF2-40B4-BE49-F238E27FC236}">
                <a16:creationId xmlns:a16="http://schemas.microsoft.com/office/drawing/2014/main" id="{351D47F2-9952-490B-8F22-8176E75E4E18}"/>
              </a:ext>
            </a:extLst>
          </p:cNvPr>
          <p:cNvSpPr txBox="1"/>
          <p:nvPr/>
        </p:nvSpPr>
        <p:spPr>
          <a:xfrm>
            <a:off x="693725" y="3368845"/>
            <a:ext cx="5742305" cy="19288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. </a:t>
            </a:r>
            <a:r>
              <a:rPr lang="en-US" sz="1100" i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orella ohadii 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cks NPQ under strict photoautotrophic conditions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b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) 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luorescence traces of dark-adapted LL (top) and HL (bottom) cells grown in strict photoautotrophic conditions, measured under 2000 </a:t>
            </a:r>
            <a:r>
              <a:rPr lang="el-GR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μ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l photons m</a:t>
            </a:r>
            <a:r>
              <a:rPr lang="en-US" sz="1100" kern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2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</a:t>
            </a:r>
            <a:r>
              <a:rPr lang="en-US" sz="1100" kern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1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Negligible NPQ was detected as indicated by the little change in maximal fluorescence (F</a:t>
            </a:r>
            <a:r>
              <a:rPr lang="en-US" sz="1100" kern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in LL and no change in HL in response to exposure to the pulses of high light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b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) 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PQ and Y(II) values were calculated from fluorescence signals as shown in panel </a:t>
            </a:r>
            <a:r>
              <a:rPr lang="en-US" sz="1100" i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he graphs are representative of at least 3 biological repeats.</a:t>
            </a:r>
            <a:endParaRPr lang="en-IL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325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</TotalTime>
  <Words>136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di Schuster Lab</dc:creator>
  <cp:lastModifiedBy>Gadi Schuster Lab</cp:lastModifiedBy>
  <cp:revision>12</cp:revision>
  <dcterms:created xsi:type="dcterms:W3CDTF">2024-05-03T07:50:48Z</dcterms:created>
  <dcterms:modified xsi:type="dcterms:W3CDTF">2024-09-19T19:50:23Z</dcterms:modified>
</cp:coreProperties>
</file>